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046AB26-E549-4561-8AD4-9596313A5B98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F070B4A-7D16-43FA-B99D-FCDC570AB4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1CA05E8-2DCE-4E39-A56D-88595B33ED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2B88EBA-1EBF-4C37-BE88-7BD92DFD7E63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398FD76-74D1-4008-9DEC-AB15F14FA2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1210A1D-389E-42A8-9048-30A6A18C21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B61CCCC-62C5-408C-86EB-B147FA19C7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F026358-F913-4E0E-A4F1-C0BCB1A52D9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6480"/>
            <a:ext cx="6170400" cy="705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EC6175E-9825-43AA-8809-2ABAC261A45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090D74B-C7C4-4553-A2F7-3CF036019D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9834B99-7789-417C-BEC6-AAB3DEA4B3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38E0428-CFD2-427F-A283-3AD7027DF7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3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0/3/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2343240" y="8475840"/>
            <a:ext cx="217152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4915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6A708287-48F8-42C1-8B65-BCE4B17F4CE2}" type="slidenum">
              <a:rPr b="0" lang="en-US" sz="18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36680" y="1981080"/>
          <a:ext cx="5715000" cy="3060720"/>
        </p:xfrm>
        <a:graphic>
          <a:graphicData uri="http://schemas.openxmlformats.org/drawingml/2006/table">
            <a:tbl>
              <a:tblPr/>
              <a:tblGrid>
                <a:gridCol w="857160"/>
                <a:gridCol w="1485720"/>
                <a:gridCol w="1371600"/>
                <a:gridCol w="2000520"/>
              </a:tblGrid>
              <a:tr h="852480"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hor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93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eographic     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ocatio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93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ntrol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93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B patient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93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  <a:tr h="493920"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hort 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936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d0d8e7"/>
                    </a:solidFill>
                  </a:tcPr>
                </a:tc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ali, Afric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936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d0d8e7"/>
                    </a:solidFill>
                  </a:tcPr>
                </a:tc>
                <a:tc>
                  <a:txBody>
                    <a:bodyPr lIns="68400" rIns="68400" tIns="76680" bIns="6084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936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d0d8e7"/>
                    </a:solidFill>
                  </a:tcPr>
                </a:tc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=14 with pulmonary TB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936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d0d8e7"/>
                    </a:solidFill>
                  </a:tcPr>
                </a:tc>
              </a:tr>
              <a:tr h="1218960"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hort 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hailan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=22  (not screened  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or LTBI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otal N=5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49 pulmonary TB and 7 with extrapulmonary TB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495360"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hort 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d0d8e7"/>
                    </a:solidFill>
                  </a:tcPr>
                </a:tc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United Stat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d0d8e7"/>
                    </a:solidFill>
                  </a:tcPr>
                </a:tc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=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d0d8e7"/>
                    </a:solidFill>
                  </a:tcPr>
                </a:tc>
                <a:tc>
                  <a:txBody>
                    <a:bodyPr lIns="68400" rIns="68400" tIns="76680" bIns="6084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d0d8e7"/>
                    </a:solidFill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399960" y="947880"/>
            <a:ext cx="5943600" cy="68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dditional file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1: Table S1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haracteristics of the cohorts used for LIPS testin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